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6" r:id="rId3"/>
    <p:sldId id="257" r:id="rId4"/>
    <p:sldId id="258" r:id="rId5"/>
    <p:sldId id="262" r:id="rId7"/>
    <p:sldId id="259" r:id="rId8"/>
    <p:sldId id="260" r:id="rId9"/>
    <p:sldId id="261" r:id="rId10"/>
  </p:sldIdLst>
  <p:sldSz cx="6858000" cy="9903460" type="A4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彭风华" initials="A" lastIdx="1" clrIdx="0"/>
  <p:cmAuthor id="2" name="Administrator" initials="A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3.xml"/><Relationship Id="rId14" Type="http://schemas.openxmlformats.org/officeDocument/2006/relationships/commentAuthors" Target="commentAuthors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758"/>
            <a:ext cx="2901255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565"/>
            <a:ext cx="2901255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758"/>
            <a:ext cx="2915543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565"/>
            <a:ext cx="2915543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2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4.xml"/><Relationship Id="rId1" Type="http://schemas.openxmlformats.org/officeDocument/2006/relationships/tags" Target="../tags/tag3.xml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2.xml"/><Relationship Id="rId2" Type="http://schemas.openxmlformats.org/officeDocument/2006/relationships/tags" Target="../tags/tag6.xml"/><Relationship Id="rId1" Type="http://schemas.openxmlformats.org/officeDocument/2006/relationships/tags" Target="../tags/tag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10.xml"/><Relationship Id="rId1" Type="http://schemas.openxmlformats.org/officeDocument/2006/relationships/tags" Target="../tags/tag9.xml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.xml"/><Relationship Id="rId3" Type="http://schemas.openxmlformats.org/officeDocument/2006/relationships/slideLayout" Target="../slideLayouts/slideLayout2.xml"/><Relationship Id="rId2" Type="http://schemas.openxmlformats.org/officeDocument/2006/relationships/tags" Target="../tags/tag12.xml"/><Relationship Id="rId1" Type="http://schemas.openxmlformats.org/officeDocument/2006/relationships/tags" Target="../tags/tag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6631" y="161598"/>
            <a:ext cx="6334363" cy="396835"/>
          </a:xfrm>
        </p:spPr>
        <p:txBody>
          <a:bodyPr>
            <a:noAutofit/>
          </a:bodyPr>
          <a:p>
            <a:r>
              <a:rPr lang="en-US" altLang="zh-CN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S1. Pathogens  identified through culture and mNGS in various specimens</a:t>
            </a:r>
            <a:r>
              <a:rPr lang="zh-CN" alt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cteria</a:t>
            </a:r>
            <a:r>
              <a:rPr lang="zh-CN" alt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endParaRPr lang="zh-CN" altLang="en-US" sz="1200" b="1" spc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346750" y="673369"/>
          <a:ext cx="6087110" cy="7437120"/>
        </p:xfrm>
        <a:graphic>
          <a:graphicData uri="http://schemas.openxmlformats.org/drawingml/2006/table">
            <a:tbl>
              <a:tblPr/>
              <a:tblGrid>
                <a:gridCol w="901065"/>
                <a:gridCol w="322580"/>
                <a:gridCol w="787400"/>
                <a:gridCol w="400050"/>
                <a:gridCol w="1176655"/>
                <a:gridCol w="525145"/>
                <a:gridCol w="795020"/>
                <a:gridCol w="1179195"/>
              </a:tblGrid>
              <a:tr h="0">
                <a:tc gridSpan="4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ure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GS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</a:t>
                      </a: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ervation fluid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</a:t>
                      </a: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ervation fluid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otal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otal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7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otal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8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ebsiella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faeci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aeruginos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aeruginos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herichia col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stutzer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alcaligene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aeruginos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putid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ebsiella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putid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ebsiella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ebsiella aerogenes 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monas fluorescen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ebsiella aerogenes 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amonas</a:t>
                      </a:r>
                      <a:r>
                        <a:rPr lang="en-US" sz="800" b="0" i="1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pp.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faecal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herichia col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herichia col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faeci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 epidermid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casseliflavu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bacter cloac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netobacter pittii 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cobacter cryaerophilu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netobacter baumann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casseliflavu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oultella ornithinolytic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hingomonas paucimobil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otella bivi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netobacter baumann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videncia stuart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phyromonas bennon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 aureu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ptococcus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faecal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ptococcus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netobacter baumann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bacter cloac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icobacter pylori 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faecal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amonas kersters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coccus gallinar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oultella ornithinolytic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illonella parvul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obacter freund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icatella adiacen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illonella parvul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ynebacterium singular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494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ptococcus pneumoniae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bacterium tuberculosis </a:t>
                      </a: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 aureu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bacterium mucogenic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 homin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notrophomonas maltophili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notrophomonas maltophilia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icobacter pylori 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ratia marcescen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mpylobacter homin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tridium tetan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tridium terti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bacterium tuberculosis </a:t>
                      </a: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bacterium mucogenic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plasma hominis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tospira</a:t>
                      </a:r>
                      <a:r>
                        <a:rPr lang="en-US" sz="800" b="0" i="1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pp.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bacterium limosum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obacter sedlakii</a:t>
                      </a:r>
                      <a:endParaRPr lang="en-US" altLang="en-US" sz="800" b="0" i="1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latin typeface="Arial" panose="020B0604020202020204" pitchFamily="34" charset="0"/>
                        <a:ea typeface="Times New Roman" panose="0202060305040502030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620" y="0"/>
            <a:ext cx="6209665" cy="746125"/>
          </a:xfrm>
        </p:spPr>
        <p:txBody>
          <a:bodyPr>
            <a:noAutofit/>
          </a:bodyPr>
          <a:p>
            <a:r>
              <a:rPr lang="en-US" altLang="zh-CN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ble </a:t>
            </a:r>
            <a:r>
              <a:rPr lang="en-US" altLang="en-US" sz="1200" b="1">
                <a:latin typeface="Arial" panose="020B0604020202020204" pitchFamily="34" charset="0"/>
                <a:cs typeface="Arial" panose="020B0604020202020204" pitchFamily="34" charset="0"/>
                <a:sym typeface="微软雅黑" panose="020B0503020204020204" charset="-122"/>
              </a:rPr>
              <a:t>S</a:t>
            </a:r>
            <a:r>
              <a:rPr lang="en-US" altLang="zh-CN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2. Pathogens identified through culture and mNGS in various  specimens</a:t>
            </a:r>
            <a:r>
              <a:rPr lang="zh-CN" alt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（</a:t>
            </a:r>
            <a:r>
              <a:rPr lang="en-US" altLang="zh-CN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ungi</a:t>
            </a:r>
            <a:r>
              <a:rPr lang="zh-CN" alt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）</a:t>
            </a:r>
            <a:endParaRPr lang="zh-CN" altLang="en-US" sz="1200" b="1" spc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aphicFrame>
        <p:nvGraphicFramePr>
          <p:cNvPr id="4" name="内容占位符 3"/>
          <p:cNvGraphicFramePr/>
          <p:nvPr>
            <p:ph idx="1"/>
            <p:custDataLst>
              <p:tags r:id="rId1"/>
            </p:custDataLst>
          </p:nvPr>
        </p:nvGraphicFramePr>
        <p:xfrm>
          <a:off x="134580" y="657763"/>
          <a:ext cx="6169660" cy="1881505"/>
        </p:xfrm>
        <a:graphic>
          <a:graphicData uri="http://schemas.openxmlformats.org/drawingml/2006/table">
            <a:tbl>
              <a:tblPr/>
              <a:tblGrid>
                <a:gridCol w="982345"/>
                <a:gridCol w="648335"/>
                <a:gridCol w="881380"/>
                <a:gridCol w="539115"/>
                <a:gridCol w="1113790"/>
                <a:gridCol w="539115"/>
                <a:gridCol w="926465"/>
                <a:gridCol w="539115"/>
              </a:tblGrid>
              <a:tr h="198755">
                <a:tc gridSpan="4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ure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GS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cP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cPr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8755"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Organ preservation fluid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 preservation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gridSpan="2"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age fluid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01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</a:t>
                      </a:r>
                      <a:endParaRPr 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6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otal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otal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6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albican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albican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albican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albican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glabrata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tropicali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andida tropicali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glabrata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glabrata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30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Rhizopus oryzae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内容占位符 3"/>
          <p:cNvGraphicFramePr/>
          <p:nvPr>
            <p:ph idx="1"/>
            <p:custDataLst>
              <p:tags r:id="rId1"/>
            </p:custDataLst>
          </p:nvPr>
        </p:nvGraphicFramePr>
        <p:xfrm>
          <a:off x="240228" y="227828"/>
          <a:ext cx="6169660" cy="4446905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598170"/>
                <a:gridCol w="868680"/>
                <a:gridCol w="1175385"/>
                <a:gridCol w="700405"/>
                <a:gridCol w="658495"/>
                <a:gridCol w="500380"/>
                <a:gridCol w="1668145"/>
              </a:tblGrid>
              <a:tr h="335280">
                <a:tc gridSpan="7"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微软雅黑" panose="020B0503020204020204" charset="-122"/>
                        </a:rPr>
                        <a:t>Table S3.</a:t>
                      </a:r>
                      <a:r>
                        <a:rPr lang="zh-CN" altLang="zh-CN"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 Comparison of positive detection</a:t>
                      </a:r>
                      <a:r>
                        <a:rPr lang="en-US" altLang="en-US"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微软雅黑" panose="020B0503020204020204" charset="-122"/>
                        </a:rPr>
                        <a:t> rate between culture and mNGS</a:t>
                      </a:r>
                      <a:r>
                        <a:rPr lang="zh-CN" altLang="zh-CN"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（</a:t>
                      </a:r>
                      <a:r>
                        <a:rPr lang="en-US" altLang="zh-CN"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N=141)</a:t>
                      </a:r>
                      <a:endParaRPr lang="en-US" altLang="zh-CN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8387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athogen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etection methods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pecimens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ositive</a:t>
                      </a: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umber</a:t>
                      </a:r>
                      <a:endParaRPr 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Positive  rate (%)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roup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zh-CN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altLang="zh-CN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8595">
                <a:tc rowSpan="7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acteria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Fluid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8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9.9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8595"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4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6550">
                <a:tc vMerge="1">
                  <a:tcPr/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.6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960">
                <a:tc vMerge="1">
                  <a:tcPr/>
                </a:tc>
                <a:tc rowSpan="3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NGS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Fluid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6.1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8595"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6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5.5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endParaRPr lang="en-US" altLang="en-US" sz="800" b="0" strike="sngStrike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6550">
                <a:tc vMerge="1">
                  <a:tcPr/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8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5.3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; 0.122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6550"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+m</a:t>
                      </a: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</a:t>
                      </a: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Organ Preservation  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+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8.2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 strike="sngStrike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960">
                <a:tc rowSpan="7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ungi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Fluid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.4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4480"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7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9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6550">
                <a:tc vMerge="1">
                  <a:tcPr/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.4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J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8595">
                <a:tc vMerge="1">
                  <a:tcPr/>
                </a:tc>
                <a:tc rowSpan="3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NGS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Fluid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.8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43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8595"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51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; 0.371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5915">
                <a:tc vMerge="1">
                  <a:tcPr/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rgan Preservation 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.2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374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j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2265">
                <a:tc vMerge="1">
                  <a:tcPr>
                    <a:lnB w="19050" cap="flat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+m</a:t>
                      </a:r>
                      <a:r>
                        <a:rPr 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</a:t>
                      </a: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l">
                        <a:buNone/>
                      </a:pPr>
                      <a:r>
                        <a:rPr 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Organ Preservation  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+Drainage Flui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7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.10%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100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j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240189" y="4674861"/>
            <a:ext cx="5301020" cy="3003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675"/>
              <a:t>Note: a, compared with Group A; </a:t>
            </a:r>
            <a:r>
              <a:rPr lang="en-US" altLang="zh-CN" sz="675"/>
              <a:t> </a:t>
            </a:r>
            <a:r>
              <a:rPr lang="zh-CN" altLang="en-US" sz="675"/>
              <a:t>b. Compared with Group </a:t>
            </a:r>
            <a:r>
              <a:rPr lang="en-US" altLang="zh-CN" sz="675"/>
              <a:t>B;</a:t>
            </a:r>
            <a:r>
              <a:rPr lang="zh-CN" altLang="en-US" sz="675"/>
              <a:t> </a:t>
            </a:r>
            <a:r>
              <a:rPr lang="en-US" altLang="zh-CN" sz="675"/>
              <a:t> </a:t>
            </a:r>
            <a:r>
              <a:rPr lang="zh-CN" altLang="en-US" sz="675"/>
              <a:t>c. Compared with Group </a:t>
            </a:r>
            <a:r>
              <a:rPr lang="en-US" altLang="zh-CN" sz="675"/>
              <a:t>C</a:t>
            </a:r>
            <a:r>
              <a:rPr lang="zh-CN" altLang="en-US" sz="675"/>
              <a:t>; </a:t>
            </a:r>
            <a:r>
              <a:rPr lang="en-US" altLang="zh-CN" sz="675"/>
              <a:t> </a:t>
            </a:r>
            <a:r>
              <a:rPr lang="zh-CN" altLang="en-US" sz="675"/>
              <a:t>d. Compared with Group </a:t>
            </a:r>
            <a:r>
              <a:rPr lang="en-US" altLang="zh-CN" sz="675"/>
              <a:t>D</a:t>
            </a:r>
            <a:r>
              <a:rPr lang="zh-CN" altLang="en-US" sz="675"/>
              <a:t>; </a:t>
            </a:r>
            <a:r>
              <a:rPr lang="en-US" altLang="zh-CN" sz="675"/>
              <a:t>  h</a:t>
            </a:r>
            <a:r>
              <a:rPr lang="zh-CN" altLang="en-US" sz="675"/>
              <a:t>. Compared with Group H;  </a:t>
            </a:r>
            <a:r>
              <a:rPr lang="en-US" altLang="zh-CN" sz="675">
                <a:sym typeface="+mn-ea"/>
              </a:rPr>
              <a:t> </a:t>
            </a:r>
            <a:r>
              <a:rPr lang="en-US" sz="675">
                <a:sym typeface="+mn-ea"/>
              </a:rPr>
              <a:t>i</a:t>
            </a:r>
            <a:r>
              <a:rPr lang="zh-CN" altLang="en-US" sz="675">
                <a:sym typeface="+mn-ea"/>
              </a:rPr>
              <a:t>. Compared with Group </a:t>
            </a:r>
            <a:r>
              <a:rPr lang="en-US" altLang="zh-CN" sz="675">
                <a:sym typeface="+mn-ea"/>
              </a:rPr>
              <a:t>I</a:t>
            </a:r>
            <a:r>
              <a:rPr lang="zh-CN" altLang="en-US" sz="675">
                <a:sym typeface="+mn-ea"/>
              </a:rPr>
              <a:t>;</a:t>
            </a:r>
            <a:r>
              <a:rPr lang="en-US" altLang="zh-CN" sz="675"/>
              <a:t>  </a:t>
            </a:r>
            <a:r>
              <a:rPr lang="zh-CN" altLang="en-US" sz="675"/>
              <a:t>j. Compared with Group J; </a:t>
            </a:r>
            <a:r>
              <a:rPr lang="en-US" altLang="zh-CN" sz="675"/>
              <a:t> </a:t>
            </a:r>
            <a:r>
              <a:rPr lang="zh-CN" altLang="en-US" sz="675"/>
              <a:t>k. Compared with Group J</a:t>
            </a:r>
            <a:r>
              <a:rPr lang="en-US" altLang="zh-CN" sz="675"/>
              <a:t>.</a:t>
            </a:r>
            <a:endParaRPr lang="en-US" altLang="zh-CN" sz="675"/>
          </a:p>
        </p:txBody>
      </p:sp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5" name="表格 4"/>
          <p:cNvGraphicFramePr/>
          <p:nvPr/>
        </p:nvGraphicFramePr>
        <p:xfrm>
          <a:off x="261938" y="488315"/>
          <a:ext cx="6048375" cy="5419725"/>
        </p:xfrm>
        <a:graphic>
          <a:graphicData uri="http://schemas.openxmlformats.org/drawingml/2006/table">
            <a:tbl>
              <a:tblPr/>
              <a:tblGrid>
                <a:gridCol w="1057275"/>
                <a:gridCol w="971550"/>
                <a:gridCol w="1457325"/>
                <a:gridCol w="666750"/>
                <a:gridCol w="809625"/>
              </a:tblGrid>
              <a:tr h="209550">
                <a:tc gridSpan="5">
                  <a:txBody>
                    <a:bodyPr/>
                    <a:p>
                      <a:pPr algn="l" fontAlgn="ctr"/>
                      <a:r>
                        <a:rPr lang="en-US" altLang="zh-CN" sz="1200" b="1" i="0">
                          <a:solidFill>
                            <a:schemeClr val="tx1"/>
                          </a:solidFill>
                          <a:latin typeface="Arial" panose="020B0604020202020204"/>
                          <a:ea typeface="Arial" panose="020B0604020202020204"/>
                        </a:rPr>
                        <a:t>Table S3. Comparison of positive detection rate between culture and mNGS</a:t>
                      </a:r>
                      <a:r>
                        <a:rPr lang="zh-CN" altLang="en-US" sz="1200" b="1" i="0">
                          <a:solidFill>
                            <a:schemeClr val="tx1"/>
                          </a:solidFill>
                          <a:latin typeface="Arial" panose="020B0604020202020204"/>
                          <a:ea typeface="Arial" panose="020B0604020202020204"/>
                        </a:rPr>
                        <a:t>（</a:t>
                      </a:r>
                      <a:r>
                        <a:rPr lang="en-US" altLang="zh-CN" sz="1200" b="1" i="0">
                          <a:solidFill>
                            <a:schemeClr val="tx1"/>
                          </a:solidFill>
                          <a:latin typeface="Arial" panose="020B0604020202020204"/>
                          <a:ea typeface="Arial" panose="020B0604020202020204"/>
                        </a:rPr>
                        <a:t>N=141)  </a:t>
                      </a:r>
                      <a:endParaRPr lang="en-US" altLang="zh-CN" sz="1200" b="1" i="0">
                        <a:solidFill>
                          <a:schemeClr val="tx1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295275">
                <a:tc rowSpan="2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athogen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etec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method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Specimen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ositiv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number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ositiv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rat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zh-CN" altLang="en-US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（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n</a:t>
                      </a:r>
                      <a:r>
                        <a:rPr lang="zh-CN" altLang="en-US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）</a:t>
                      </a:r>
                      <a:endParaRPr lang="zh-CN" altLang="en-US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</a:tr>
              <a:tr h="0">
                <a:tc rowSpan="7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Bacteria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9.9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.4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9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0.6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6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6.1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5.5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7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5.3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+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8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8.2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71450">
                <a:tc rowSpan="7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ungi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6.4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71450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0.7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6.4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71450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7.8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.1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3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.2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+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2.1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rowSpan="7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Bacteria and/or Fungi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4.8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.1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5.5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rowSpan="3"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6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7.5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09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7.0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</a:tcPr>
                </a:tc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84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9.6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5275">
                <a:tc vMerge="1">
                  <a:tcPr>
                    <a:lnL>
                      <a:noFill/>
                    </a:lnL>
                    <a:lnR>
                      <a:noFill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ulture+mNGS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l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Orga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reservation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+Drainage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Fluid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8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62.4%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9842" marR="9842" marT="9842" marB="0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9619" y="118140"/>
            <a:ext cx="5915025" cy="745629"/>
          </a:xfrm>
        </p:spPr>
        <p:txBody>
          <a:bodyPr>
            <a:noAutofit/>
          </a:bodyPr>
          <a:p>
            <a:r>
              <a:rPr lang="en-US" alt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微软雅黑" panose="020B0503020204020204" charset="-122"/>
              </a:rPr>
              <a:t>Table</a:t>
            </a:r>
            <a:r>
              <a:rPr lang="en-US" sz="1200" b="1" spc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S4. Proportion of pathogens detected in different specimens</a:t>
            </a:r>
            <a:endParaRPr lang="en-US" altLang="en-US" sz="1200" b="1" spc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aphicFrame>
        <p:nvGraphicFramePr>
          <p:cNvPr id="4" name="表格 3"/>
          <p:cNvGraphicFramePr/>
          <p:nvPr/>
        </p:nvGraphicFramePr>
        <p:xfrm>
          <a:off x="260469" y="625307"/>
          <a:ext cx="3889375" cy="1621155"/>
        </p:xfrm>
        <a:graphic>
          <a:graphicData uri="http://schemas.openxmlformats.org/drawingml/2006/table">
            <a:tbl>
              <a:tblPr/>
              <a:tblGrid>
                <a:gridCol w="1446530"/>
                <a:gridCol w="653415"/>
                <a:gridCol w="562610"/>
                <a:gridCol w="659130"/>
                <a:gridCol w="567690"/>
              </a:tblGrid>
              <a:tr h="153035">
                <a:tc gridSpan="5">
                  <a:txBody>
                    <a:bodyPr/>
                    <a:p>
                      <a:pPr indent="0" algn="ctr">
                        <a:buNone/>
                      </a:pPr>
                      <a:endParaRPr lang="en-US" altLang="en-US" sz="79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15240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ure positive n(%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</a:tcPr>
                </a:tc>
                <a:tc grid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S positive n(%)    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</a:tcPr>
                </a:tc>
              </a:tr>
              <a:tr h="23939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icroorganism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rvation fluid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ge fluid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rvation fluid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ainge fluid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3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9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5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24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- enterobacteriaceae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(41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.0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(29.3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(25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430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n-fermenting bacteria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(12.8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(23.2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(32.7)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微软雅黑" panose="020B0503020204020204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ther G- bacteria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(5.1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(7.1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(11.5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811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+ bacteria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(17.9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(66.7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(17.2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(21.2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24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aerobic bacteria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(11.1)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微软雅黑" panose="020B0503020204020204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(1.9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algn="l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ungus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l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(23.1）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(33.3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(12.1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(7.7)</a:t>
                      </a:r>
                      <a:r>
                        <a:rPr lang="en-US" sz="800" b="0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altLang="en-US" sz="800" b="0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微软雅黑" panose="020B0503020204020204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260469" y="2348657"/>
            <a:ext cx="3779044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indent="0">
              <a:buNone/>
            </a:pPr>
            <a:r>
              <a:rPr lang="en-US" sz="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a p&lt;0.05,  compared with culture-positive results in presevation fluid</a:t>
            </a:r>
            <a:r>
              <a:rPr lang="en-US" sz="800"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</a:t>
            </a:r>
            <a:endParaRPr lang="en-US" altLang="en-US" sz="800">
              <a:solidFill>
                <a:srgbClr val="000000"/>
              </a:solidFill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内容占位符 3"/>
          <p:cNvGraphicFramePr/>
          <p:nvPr>
            <p:ph idx="1"/>
            <p:custDataLst>
              <p:tags r:id="rId1"/>
            </p:custDataLst>
          </p:nvPr>
        </p:nvGraphicFramePr>
        <p:xfrm>
          <a:off x="146010" y="394714"/>
          <a:ext cx="6169660" cy="5980430"/>
        </p:xfrm>
        <a:graphic>
          <a:graphicData uri="http://schemas.openxmlformats.org/drawingml/2006/table">
            <a:tbl>
              <a:tblPr/>
              <a:tblGrid>
                <a:gridCol w="972820"/>
                <a:gridCol w="1352550"/>
                <a:gridCol w="1132205"/>
                <a:gridCol w="1344295"/>
                <a:gridCol w="1367790"/>
              </a:tblGrid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nly culture detecte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oth culture and mNGS detecte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nly mNGS detected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98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LL, n(%</a:t>
                      </a: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(15.9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(13.1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(71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716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G- bacteria, n</a:t>
                      </a:r>
                      <a:r>
                        <a:rPr lang="en-US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%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(13.5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US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13.5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(73.0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4305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Klebsiella pneumoniae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986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Klebsiella aerogenes 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scherichia col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986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nterobacter cloacae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itrobacter freundi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4305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itrobacter sedlaki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erratia marcescen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Raoultella ornithinolytic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351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rovidencia stuarti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145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hingomonas paucimobili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seudomonas aeruginos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seudomonas putid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Acinetobacter baumanni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986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Acinetobacter pittii 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5425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tenotrophomonas maltophili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9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+ bacteria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, n</a:t>
                      </a:r>
                      <a:r>
                        <a:rPr lang="en-US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%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(25.9)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(7.4)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8(66.7)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nterococcus faecium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nterococcus faecali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nterococcus casseliflavu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taphylococcus aureu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taphylococcus epidermidi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treptococcus pneumoniae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ycobacterium tuberculosis 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ycobacterium mucogenicum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others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96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naerobic bacteria, 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n</a:t>
                      </a:r>
                      <a:r>
                        <a:rPr lang="en-US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%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(0.0)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(0.0</a:t>
                      </a:r>
                      <a:r>
                        <a:rPr lang="zh-CN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</a:t>
                      </a:r>
                      <a:r>
                        <a:rPr lang="zh-CN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0.0</a:t>
                      </a:r>
                      <a:r>
                        <a:rPr lang="zh-CN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orphyromonas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986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revotella bivi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Eubacterium limosum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Veillonella parvula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lostridium tetani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lostridium tertium</a:t>
                      </a:r>
                      <a:endParaRPr lang="en-US" alt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ungi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, n</a:t>
                      </a:r>
                      <a:r>
                        <a:rPr lang="en-US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(%)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2.2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7.8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0.0</a:t>
                      </a:r>
                      <a:r>
                        <a:rPr lang="zh-CN" alt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zh-CN" altLang="en-US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albican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glabrata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dida tropicalis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5890">
                <a:tc>
                  <a:txBody>
                    <a:bodyPr/>
                    <a:p>
                      <a:pPr indent="0">
                        <a:buNone/>
                      </a:pP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 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izopus oryzae</a:t>
                      </a:r>
                      <a:endParaRPr lang="en-US" sz="800" b="0" i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145733" y="46385"/>
            <a:ext cx="6035397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ble S5. </a:t>
            </a:r>
            <a:r>
              <a:rPr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mparison of Culture and mNGS for Pathogens</a:t>
            </a:r>
            <a:r>
              <a:rPr 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etection</a:t>
            </a:r>
            <a:r>
              <a:rPr lang="en-US" altLang="zh-CN" sz="1125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endParaRPr lang="en-US" altLang="zh-CN" sz="1125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内容占位符 3"/>
          <p:cNvGraphicFramePr/>
          <p:nvPr>
            <p:ph idx="1"/>
            <p:custDataLst>
              <p:tags r:id="rId1"/>
            </p:custDataLst>
          </p:nvPr>
        </p:nvGraphicFramePr>
        <p:xfrm>
          <a:off x="240030" y="314960"/>
          <a:ext cx="6212840" cy="695198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575310"/>
                <a:gridCol w="572135"/>
                <a:gridCol w="636270"/>
                <a:gridCol w="1462405"/>
                <a:gridCol w="1391285"/>
                <a:gridCol w="1575435"/>
              </a:tblGrid>
              <a:tr h="398145">
                <a:tc gridSpan="6">
                  <a:txBody>
                    <a:bodyPr/>
                    <a:p>
                      <a:pPr indent="0" algn="l">
                        <a:buNone/>
                      </a:pPr>
                      <a:r>
                        <a:rPr lang="en-US" altLang="zh-CN" sz="1200" b="1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able S6. </a:t>
                      </a:r>
                      <a:r>
                        <a:rPr sz="12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ed Pathogen Information for 19 Patients Re-admitted Due to Infections Among 141 Recipients</a:t>
                      </a:r>
                      <a:endParaRPr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321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erial </a:t>
                      </a: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umber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ase number</a:t>
                      </a:r>
                      <a:endParaRPr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Infection time 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(pod)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eadmission   diagnosis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athogens detected  while readmission</a:t>
                      </a:r>
                      <a:endParaRPr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athogens detected perioperation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8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5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ungal sepsis, 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lood and urine,culture: Candida parapsi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 and NGS, Preservation fluid and Drainge fluid: Pseudomonas aeruginosa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ever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irus B19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, Preservation fluid: Escherichia coli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61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4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lmonary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ycobacterium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Preservation fluid: Mycobacterium tuberculosis;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Drainge fluid: Candida albican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034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3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andida parapsi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1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2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epsis; 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e,culture: 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3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ever; virus infection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Preservation fluid: Acinetobacter baumannii and Escherichia coli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7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5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lmonary infection: Pulmonary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ycobacterium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Preservation fluid and  Drainge fluid: Mycobacterium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034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 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3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1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4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lmonary infection; 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e,culture: Enterococcus faecium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1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2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ever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，Preservation fluid: Candida glabrata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6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8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lebsiella pneumoniae;Escherichia coli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 and NGS, Preservation fluid: Escherichia coli and Candida albican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scherichia coli,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 and NGS, Preservation fluid: Escherichia coli and Candida albican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1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4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e,culture: 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4</a:t>
                      </a:r>
                      <a:endParaRPr 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1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ary tract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rine,culture: Escherichia coli，Proteus mirabil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5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6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lmonary infectio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lture and NGS, Preservation fluid and Drainge fluid: 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06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6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8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2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ever; bacteremia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taphylococcus haemolyticu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002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7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5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6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lmonary 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uberculosi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8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9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7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utaneous fungi infections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ungi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Drainge fluid: 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22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  <a:sym typeface="+mn-ea"/>
                        </a:rPr>
                        <a:t>19</a:t>
                      </a:r>
                      <a:endParaRPr lang="en-US" altLang="en-US" sz="800" b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143" marR="7143" marT="7143" marB="25717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4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oor wound healing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800" b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GS, Preservation fluid: Klebsiella pneumoniae</a:t>
                      </a:r>
                      <a:endParaRPr lang="en-US" sz="800" b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>
                      <a:solidFill>
                        <a:srgbClr val="000000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240189" y="7319636"/>
            <a:ext cx="5301020" cy="1955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sz="675"/>
              <a:t>Note: Case 106 and 107 share the same donor</a:t>
            </a:r>
            <a:endParaRPr sz="675"/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720*415"/>
  <p:tag name="TABLE_ENDDRAG_RECT" val="115*103*720*415"/>
</p:tagLst>
</file>

<file path=ppt/tags/tag1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.xml><?xml version="1.0" encoding="utf-8"?>
<p:tagLst xmlns:p="http://schemas.openxmlformats.org/presentationml/2006/main">
  <p:tag name="KSO_WM_UNIT_TABLE_BEAUTIFY" val="smartTable{ea07907e-d286-46a0-b1dc-2cd5fcb5852d}"/>
  <p:tag name="TABLE_ENDDRAG_ORIGIN_RECT" val="511*409"/>
  <p:tag name="TABLE_ENDDRAG_RECT" val="18*24*511*409"/>
  <p:tag name="KSO_WM_BEAUTIFY_FLAG" val=""/>
</p:tagLst>
</file>

<file path=ppt/tags/tag1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3.xml><?xml version="1.0" encoding="utf-8"?>
<p:tagLst xmlns:p="http://schemas.openxmlformats.org/presentationml/2006/main">
  <p:tag name="commondata" val="eyJoZGlkIjoiOGQxMzA0MTk2NGZjMDFlN2E3NmE4ZmNlZDUxMjQxMzYifQ=="/>
</p:tagLst>
</file>

<file path=ppt/tags/tag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3.xml><?xml version="1.0" encoding="utf-8"?>
<p:tagLst xmlns:p="http://schemas.openxmlformats.org/presentationml/2006/main">
  <p:tag name="KSO_WM_UNIT_TABLE_BEAUTIFY" val="smartTable{51180920-73f4-43d0-bc34-eb17c14737a1}"/>
  <p:tag name="TABLE_ENDDRAG_ORIGIN_RECT" val="678*294"/>
  <p:tag name="TABLE_ENDDRAG_RECT" val="26*114*678*294"/>
  <p:tag name="KSO_WM_BEAUTIFY_FLAG" val=""/>
</p:tagLst>
</file>

<file path=ppt/tags/tag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5.xml><?xml version="1.0" encoding="utf-8"?>
<p:tagLst xmlns:p="http://schemas.openxmlformats.org/presentationml/2006/main">
  <p:tag name="KSO_WM_UNIT_TABLE_BEAUTIFY" val="smartTable{e5cb946d-a558-44e4-a14f-0fce1a500398}"/>
  <p:tag name="TABLE_ENDDRAG_ORIGIN_RECT" val="904*420"/>
  <p:tag name="TABLE_ENDDRAG_RECT" val="31*109*904*420"/>
  <p:tag name="KSO_WM_BEAUTIFY_FLAG" val=""/>
</p:tagLst>
</file>

<file path=ppt/tags/tag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.xml><?xml version="1.0" encoding="utf-8"?>
<p:tagLst xmlns:p="http://schemas.openxmlformats.org/presentationml/2006/main">
  <p:tag name="KSO_WM_UNIT_TABLE_BEAUTIFY" val="smartTable{428909d2-14fe-4783-92ea-9abc40bf8885}"/>
  <p:tag name="TABLE_ENDDRAG_ORIGIN_RECT" val="561*702"/>
  <p:tag name="TABLE_ENDDRAG_RECT" val="208*0*561*702"/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72</Words>
  <Application>WPS 演示</Application>
  <PresentationFormat>宽屏</PresentationFormat>
  <Paragraphs>1811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6" baseType="lpstr">
      <vt:lpstr>Arial</vt:lpstr>
      <vt:lpstr>宋体</vt:lpstr>
      <vt:lpstr>Wingdings</vt:lpstr>
      <vt:lpstr>Times New Roman</vt:lpstr>
      <vt:lpstr>微软雅黑</vt:lpstr>
      <vt:lpstr>Arial</vt:lpstr>
      <vt:lpstr>Arial Unicode MS</vt:lpstr>
      <vt:lpstr>Calibri</vt:lpstr>
      <vt:lpstr>WPS</vt:lpstr>
      <vt:lpstr>Table S1. Pathogens  identified through culture and mNGS in various specimens（Bacteria）</vt:lpstr>
      <vt:lpstr>Table S2. Pathogens identified through culture and mNGS in various  specimens（Fungi）</vt:lpstr>
      <vt:lpstr>PowerPoint 演示文稿</vt:lpstr>
      <vt:lpstr>PowerPoint 演示文稿</vt:lpstr>
      <vt:lpstr>Table S4. Proportion of pathogens detected in different specimen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Lijiyuan</cp:lastModifiedBy>
  <cp:revision>12</cp:revision>
  <dcterms:created xsi:type="dcterms:W3CDTF">2023-08-09T12:44:00Z</dcterms:created>
  <dcterms:modified xsi:type="dcterms:W3CDTF">2025-06-23T13:49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350307991294F3684235735C69390FD_13</vt:lpwstr>
  </property>
  <property fmtid="{D5CDD505-2E9C-101B-9397-08002B2CF9AE}" pid="3" name="KSOProductBuildVer">
    <vt:lpwstr>2052-12.1.0.21171</vt:lpwstr>
  </property>
</Properties>
</file>